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7" r:id="rId2"/>
    <p:sldId id="268" r:id="rId3"/>
    <p:sldId id="269" r:id="rId4"/>
    <p:sldId id="273" r:id="rId5"/>
    <p:sldId id="27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70"/>
  </p:normalViewPr>
  <p:slideViewPr>
    <p:cSldViewPr snapToGrid="0" snapToObjects="1">
      <p:cViewPr varScale="1">
        <p:scale>
          <a:sx n="112" d="100"/>
          <a:sy n="112" d="100"/>
        </p:scale>
        <p:origin x="4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34528F-439F-784A-96F7-C935E56D0BA2}" type="datetimeFigureOut">
              <a:rPr lang="en-US" smtClean="0"/>
              <a:t>9/3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36ADB6-3AF0-7D42-A157-164B7A2394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645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srgbClr val="FF0000"/>
                </a:solidFill>
                <a:latin typeface="Times" pitchFamily="2" charset="0"/>
              </a:rPr>
              <a:t>*5 days post colonisation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CC9D4D-B341-414B-AE3B-75F7DF2F91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556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BAB55-DED2-D549-A502-22D3E7EDDD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EBFECB-EC6B-F54D-8C4B-29C763E80D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E0B08B-264E-1345-9064-BD48C4737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BF2B52-681B-D74B-BB98-0214B8C33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3BABEB-9D79-3B44-B6B7-4A0805572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95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1B9FCB-A17C-0A4F-8924-90AB742D33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982474-4557-CB4B-A5FE-B2CF93CDB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2D446A-D886-C74C-8907-D70190A1A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28DD3B-3684-8549-BBC9-BF075E7FA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7A5D39-6C0D-1444-A434-D1DD25704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92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C5C893-CAD8-E74B-8364-906E6E5CD6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C970D6-D557-1343-BC8A-D68875477A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542AE-594A-924A-A3A1-26BBD0A2E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CE890-CC47-DB42-B71B-D0A00696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55B54-E77D-A542-9E35-4FD634D77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583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0C7F8-E481-FA46-AD3D-8BC1E2591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D8BC6A-6646-314C-BDA1-AC6308106B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BD5A3-7091-C64B-BF4A-FF2199CAA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E4BB47-4093-6646-A67A-D049903E3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9D292-2D69-E94B-B265-04FCA0AEE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21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B1E4C-F84C-9245-9FCA-547954653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F3CF60-739C-4C47-BE03-BB6CE948F2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AF02C6-5610-D84C-8E57-27B3A885E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457778-A6AD-CC48-9251-A71C85B53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402847-CD82-AB49-A8E8-9374629D9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11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379DA5-DCE4-CD45-ABF2-354144306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97F711-6A99-0D4E-B9A0-1DB9793730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4F8EB0-A095-944E-9925-7EB98FB436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99D2DF-F8BA-CE45-AA42-63045D1D2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68245B-C1FC-A242-90CE-B1E86DD86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C564BF-42DC-224E-BB8F-537F1C631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600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4AB06-044C-584F-954D-AEE84EA67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875AFA-A8D2-4842-8453-A8A68B1D10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25644F-931D-4B46-B980-EDBA698FA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84B07E-893C-724D-A170-256C3BA58C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D7B7A9-B310-FA4B-9B7C-0365900AB3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BAE06E-D0B4-3A40-B732-61B7C1DFC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83110A-F06B-4D42-835D-986C7B128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983F-EF42-6D4D-955D-1DC62F2AA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70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331B5-E3D4-924A-B45C-9A26CB157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997E31-54FC-7841-B307-FA802A560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3818A6-696A-3A47-9D46-02D88769B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E667A0-CE29-0E4D-8F57-05154F236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2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5A41DA-8BE3-0444-A833-F41008D33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0E9F42-F400-D842-9C5A-A08D5185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7C0E2B-7506-2B42-93E4-C2FB2C467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02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42101-45F7-E143-A962-43C67B5FE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B9A5C3-D72C-4B45-82BF-8D087574B6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C81CEC-F5DA-6841-8B2A-FDE359AD1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7B4CCD-3B41-A649-B1C7-4476AC532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DBD7AD-DBE4-384C-B82A-D70EBABD5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68992B-3F14-AD47-8EF0-5F586222C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627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3E2E0-4AB2-6440-BF1E-82E8ABB59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C5D12D-1AA9-5C4E-AAF7-50BB0732AE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9E1943-75DE-1244-B118-616693E4B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B56B9-931A-E342-B718-432F5B312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924BA4-9028-EC43-BD57-D0521EC10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AD80A9-8DDC-A94A-BCE9-B0E52821B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922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080041-5F38-EE4B-AC11-21A78A623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C95C9D-F34F-6149-81CB-FEB8F3509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7EDB3C-E88A-AA4E-A968-FD45153CF9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F0EF4A-5AD7-F341-8024-2B7ABD83F5B7}" type="datetimeFigureOut">
              <a:rPr lang="en-US" smtClean="0"/>
              <a:t>9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31DA99-BCDF-E04E-B23D-A6C242B30A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036AD-A133-104A-82CE-13537F33E7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DD5C-9DF2-3D42-BF3E-D71F129113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70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4FF6CC-405D-B547-B930-D10FF968ADBF}"/>
              </a:ext>
            </a:extLst>
          </p:cNvPr>
          <p:cNvSpPr txBox="1"/>
          <p:nvPr/>
        </p:nvSpPr>
        <p:spPr>
          <a:xfrm>
            <a:off x="2143125" y="1207034"/>
            <a:ext cx="6057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Supplementary Table 1. Distribution of </a:t>
            </a:r>
            <a:r>
              <a:rPr lang="en-GB" sz="1200" b="1" i="1" dirty="0">
                <a:latin typeface="Times New Roman"/>
                <a:cs typeface="Times New Roman"/>
              </a:rPr>
              <a:t>Bt</a:t>
            </a:r>
            <a:r>
              <a:rPr lang="en-GB" sz="1200" b="1" dirty="0">
                <a:latin typeface="Times New Roman"/>
                <a:cs typeface="Times New Roman"/>
              </a:rPr>
              <a:t> in the GIT of mono-colonised germfree mice </a:t>
            </a:r>
            <a:endParaRPr lang="en-GB" sz="1200" dirty="0">
              <a:latin typeface="Times New Roman"/>
              <a:cs typeface="Times New Roman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92300BD-2B4F-A447-B4C8-A27991681978}"/>
              </a:ext>
            </a:extLst>
          </p:cNvPr>
          <p:cNvGraphicFramePr>
            <a:graphicFrameLocks noGrp="1"/>
          </p:cNvGraphicFramePr>
          <p:nvPr/>
        </p:nvGraphicFramePr>
        <p:xfrm>
          <a:off x="2143125" y="1688206"/>
          <a:ext cx="7162750" cy="3889934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023250">
                  <a:extLst>
                    <a:ext uri="{9D8B030D-6E8A-4147-A177-3AD203B41FA5}">
                      <a16:colId xmlns:a16="http://schemas.microsoft.com/office/drawing/2014/main" val="708036475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2963560842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3123775858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1986599634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2830182496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817957689"/>
                    </a:ext>
                  </a:extLst>
                </a:gridCol>
                <a:gridCol w="1023250">
                  <a:extLst>
                    <a:ext uri="{9D8B030D-6E8A-4147-A177-3AD203B41FA5}">
                      <a16:colId xmlns:a16="http://schemas.microsoft.com/office/drawing/2014/main" val="1615695125"/>
                    </a:ext>
                  </a:extLst>
                </a:gridCol>
              </a:tblGrid>
              <a:tr h="706469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ouse ID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Duodenum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Jejunum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leum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aecum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roximal Colon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Distal </a:t>
                      </a:r>
                    </a:p>
                    <a:p>
                      <a:pPr algn="ctr"/>
                      <a:r>
                        <a:rPr lang="en-US" sz="1200" dirty="0"/>
                        <a:t>Colon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7275827"/>
                  </a:ext>
                </a:extLst>
              </a:tr>
              <a:tr h="63669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1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0.0*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2.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.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07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9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30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677726"/>
                  </a:ext>
                </a:extLst>
              </a:tr>
              <a:tr h="63669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3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.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.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.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2.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7.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9.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515030"/>
                  </a:ext>
                </a:extLst>
              </a:tr>
              <a:tr h="63669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55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.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.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.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3.9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2.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7.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4702447"/>
                  </a:ext>
                </a:extLst>
              </a:tr>
              <a:tr h="63669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5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.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8.9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1.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2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0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5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3878616"/>
                  </a:ext>
                </a:extLst>
              </a:tr>
              <a:tr h="63669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5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.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.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.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1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6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5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39169113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556179BE-8A15-9E4D-8C58-B5D7AB1237A9}"/>
              </a:ext>
            </a:extLst>
          </p:cNvPr>
          <p:cNvSpPr/>
          <p:nvPr/>
        </p:nvSpPr>
        <p:spPr>
          <a:xfrm>
            <a:off x="2143125" y="5709487"/>
            <a:ext cx="183553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/>
                <a:cs typeface="Times New Roman"/>
              </a:rPr>
              <a:t> * cfu/g of contents (x10</a:t>
            </a:r>
            <a:r>
              <a:rPr lang="en-GB" sz="1200" baseline="30000" dirty="0">
                <a:latin typeface="Times New Roman"/>
                <a:cs typeface="Times New Roman"/>
              </a:rPr>
              <a:t>6</a:t>
            </a:r>
            <a:r>
              <a:rPr lang="en-GB" sz="1200" dirty="0">
                <a:latin typeface="Times New Roman"/>
                <a:cs typeface="Times New Roman"/>
              </a:rPr>
              <a:t>)</a:t>
            </a:r>
            <a:endParaRPr lang="en-US" sz="1200" strike="sngStrike" dirty="0">
              <a:highlight>
                <a:srgbClr val="FFFF00"/>
              </a:highlight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3EC9853-A56A-714C-8B49-AA4B117E37CA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81359" y="231860"/>
            <a:ext cx="2181025" cy="663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5484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A6DC3C4-AFDC-AB46-ABA1-8854C4D07B15}"/>
              </a:ext>
            </a:extLst>
          </p:cNvPr>
          <p:cNvSpPr txBox="1"/>
          <p:nvPr/>
        </p:nvSpPr>
        <p:spPr>
          <a:xfrm>
            <a:off x="1438278" y="1013311"/>
            <a:ext cx="9448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Supplementary Table 2. Mixed effects analysis to compare ChrA, GLP-1, GIP and 5-HT intestinal cell numbers in SPF, GF and </a:t>
            </a:r>
            <a:r>
              <a:rPr lang="en-GB" sz="1200" b="1" dirty="0" err="1">
                <a:latin typeface="Times New Roman"/>
                <a:cs typeface="Times New Roman"/>
              </a:rPr>
              <a:t>GF</a:t>
            </a:r>
            <a:r>
              <a:rPr lang="en-GB" sz="1200" b="1" i="1" dirty="0" err="1">
                <a:latin typeface="Times New Roman"/>
                <a:cs typeface="Times New Roman"/>
              </a:rPr>
              <a:t>Bt</a:t>
            </a:r>
            <a:r>
              <a:rPr lang="en-GB" sz="1200" b="1" dirty="0">
                <a:latin typeface="Times New Roman"/>
                <a:cs typeface="Times New Roman"/>
              </a:rPr>
              <a:t> mice </a:t>
            </a:r>
            <a:endParaRPr lang="en-GB" sz="1200" dirty="0">
              <a:latin typeface="Times New Roman"/>
              <a:cs typeface="Times New Roman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DB43C5B-154F-F946-B09C-FA489AFA5BD4}"/>
              </a:ext>
            </a:extLst>
          </p:cNvPr>
          <p:cNvGraphicFramePr>
            <a:graphicFrameLocks noGrp="1"/>
          </p:cNvGraphicFramePr>
          <p:nvPr/>
        </p:nvGraphicFramePr>
        <p:xfrm>
          <a:off x="1438278" y="1386292"/>
          <a:ext cx="9748834" cy="3467645"/>
        </p:xfrm>
        <a:graphic>
          <a:graphicData uri="http://schemas.openxmlformats.org/drawingml/2006/table">
            <a:tbl>
              <a:tblPr/>
              <a:tblGrid>
                <a:gridCol w="4300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84715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321009">
                <a:tc>
                  <a:txBody>
                    <a:bodyPr/>
                    <a:lstStyle/>
                    <a:p>
                      <a:pPr algn="ctr" fontAlgn="ctr"/>
                      <a:r>
                        <a:rPr lang="sk-S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uode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eju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le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xim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st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8564">
                <a:tc>
                  <a:txBody>
                    <a:bodyPr/>
                    <a:lstStyle/>
                    <a:p>
                      <a:pPr algn="ctr" fontAlgn="ctr"/>
                      <a:r>
                        <a:rPr lang="sk-SK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100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A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8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98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100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SPF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1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3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4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83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70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100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LP1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9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95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67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100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SPF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81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1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30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38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19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100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IP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5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2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03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5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0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100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SPF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88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9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17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9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100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HT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GFBt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79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5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4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&lt;</a:t>
                      </a: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100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SPF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9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6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2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&lt;</a:t>
                      </a: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3F45B7A3-C685-5948-9852-6E2DA27A051E}"/>
              </a:ext>
            </a:extLst>
          </p:cNvPr>
          <p:cNvSpPr/>
          <p:nvPr/>
        </p:nvSpPr>
        <p:spPr>
          <a:xfrm>
            <a:off x="1381125" y="4924315"/>
            <a:ext cx="98631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/>
                <a:cs typeface="Times New Roman"/>
              </a:rPr>
              <a:t>Two-Way ANOVA preformed on raw data comparing enteroendocrine cell numbers in SPF, GF and </a:t>
            </a:r>
            <a:r>
              <a:rPr lang="en-GB" sz="1200" dirty="0" err="1">
                <a:latin typeface="Times New Roman"/>
                <a:cs typeface="Times New Roman"/>
              </a:rPr>
              <a:t>GF</a:t>
            </a:r>
            <a:r>
              <a:rPr lang="en-GB" sz="1200" i="1" dirty="0" err="1">
                <a:latin typeface="Times New Roman"/>
                <a:cs typeface="Times New Roman"/>
              </a:rPr>
              <a:t>Bt</a:t>
            </a:r>
            <a:r>
              <a:rPr lang="en-GB" sz="1200" dirty="0">
                <a:latin typeface="Times New Roman"/>
                <a:cs typeface="Times New Roman"/>
              </a:rPr>
              <a:t> mice (GraphPad Prism ®). </a:t>
            </a:r>
            <a:r>
              <a:rPr lang="en-GB" sz="1200" dirty="0" err="1">
                <a:latin typeface="Times New Roman"/>
                <a:cs typeface="Times New Roman"/>
              </a:rPr>
              <a:t>Geisser</a:t>
            </a:r>
            <a:r>
              <a:rPr lang="en-GB" sz="1200" dirty="0">
                <a:latin typeface="Times New Roman"/>
                <a:cs typeface="Times New Roman"/>
              </a:rPr>
              <a:t>-Greenhouse correction was not used. *p&lt;0.05, **p&lt;0.01 and ***p&lt;0.001 were considered statistically significant. </a:t>
            </a:r>
            <a:endParaRPr lang="en-US" sz="12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DE48241-0EBE-B44E-A9EB-D9116D0189D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81359" y="173495"/>
            <a:ext cx="2181025" cy="663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002646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2C4986D-A4B9-1841-AF79-0FB9D7BFE334}"/>
              </a:ext>
            </a:extLst>
          </p:cNvPr>
          <p:cNvSpPr txBox="1"/>
          <p:nvPr/>
        </p:nvSpPr>
        <p:spPr>
          <a:xfrm>
            <a:off x="1403115" y="1120999"/>
            <a:ext cx="93857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Supplementary Table 3. Mixed effects analysis to compare ChrA, GLP-1, GIP and 5-HT intestinal cell numbers in GF, </a:t>
            </a:r>
            <a:r>
              <a:rPr lang="en-GB" sz="1200" b="1" dirty="0" err="1">
                <a:latin typeface="Times New Roman"/>
                <a:cs typeface="Times New Roman"/>
              </a:rPr>
              <a:t>GF</a:t>
            </a:r>
            <a:r>
              <a:rPr lang="en-GB" sz="1200" b="1" i="1" dirty="0" err="1">
                <a:latin typeface="Times New Roman"/>
                <a:cs typeface="Times New Roman"/>
              </a:rPr>
              <a:t>Bt</a:t>
            </a:r>
            <a:r>
              <a:rPr lang="en-GB" sz="1200" b="1" i="1" dirty="0">
                <a:latin typeface="Times New Roman"/>
                <a:cs typeface="Times New Roman"/>
              </a:rPr>
              <a:t> and </a:t>
            </a:r>
            <a:r>
              <a:rPr lang="en-GB" sz="1200" b="1" dirty="0" err="1">
                <a:latin typeface="Times New Roman"/>
                <a:cs typeface="Times New Roman"/>
              </a:rPr>
              <a:t>GF</a:t>
            </a:r>
            <a:r>
              <a:rPr lang="en-GB" sz="1200" b="1" i="1" dirty="0" err="1">
                <a:latin typeface="Times New Roman"/>
                <a:cs typeface="Times New Roman"/>
              </a:rPr>
              <a:t>Lr</a:t>
            </a:r>
            <a:r>
              <a:rPr lang="en-GB" sz="1200" b="1" dirty="0">
                <a:latin typeface="Times New Roman"/>
                <a:cs typeface="Times New Roman"/>
              </a:rPr>
              <a:t> mice. </a:t>
            </a:r>
            <a:endParaRPr lang="en-GB" sz="1200" dirty="0">
              <a:latin typeface="Times New Roman"/>
              <a:cs typeface="Times New Roman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A445D66-84B9-CE45-BA3B-99CFF7F990FC}"/>
              </a:ext>
            </a:extLst>
          </p:cNvPr>
          <p:cNvGraphicFramePr>
            <a:graphicFrameLocks noGrp="1"/>
          </p:cNvGraphicFramePr>
          <p:nvPr/>
        </p:nvGraphicFramePr>
        <p:xfrm>
          <a:off x="1071563" y="1529213"/>
          <a:ext cx="9986962" cy="3414262"/>
        </p:xfrm>
        <a:graphic>
          <a:graphicData uri="http://schemas.openxmlformats.org/drawingml/2006/table">
            <a:tbl>
              <a:tblPr/>
              <a:tblGrid>
                <a:gridCol w="4406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867851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331712"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uode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eju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le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xim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st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8854"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171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A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0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9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24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3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6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317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GFLr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24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5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92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5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8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171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LP1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16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2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85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6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0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317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GFLr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86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61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49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90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01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3171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IP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B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4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6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4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9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317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L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0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56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14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63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35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3171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HT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GFBt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32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5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0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&lt;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317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GFLr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77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92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33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6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2B612487-CFF5-4E4A-9D75-9337EC036FF5}"/>
              </a:ext>
            </a:extLst>
          </p:cNvPr>
          <p:cNvSpPr/>
          <p:nvPr/>
        </p:nvSpPr>
        <p:spPr>
          <a:xfrm>
            <a:off x="1071562" y="5012226"/>
            <a:ext cx="1012983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/>
                <a:cs typeface="Times New Roman"/>
              </a:rPr>
              <a:t>Two-Way ANOVA preformed on raw data comparing enteroendocrine cell numbers among GF, </a:t>
            </a:r>
            <a:r>
              <a:rPr lang="en-GB" sz="1200" dirty="0" err="1">
                <a:latin typeface="Times New Roman"/>
                <a:cs typeface="Times New Roman"/>
              </a:rPr>
              <a:t>GF</a:t>
            </a:r>
            <a:r>
              <a:rPr lang="en-GB" sz="1200" i="1" dirty="0" err="1">
                <a:latin typeface="Times New Roman"/>
                <a:cs typeface="Times New Roman"/>
              </a:rPr>
              <a:t>Bt</a:t>
            </a:r>
            <a:r>
              <a:rPr lang="en-GB" sz="1200" dirty="0">
                <a:latin typeface="Times New Roman"/>
                <a:cs typeface="Times New Roman"/>
              </a:rPr>
              <a:t> and </a:t>
            </a:r>
            <a:r>
              <a:rPr lang="en-GB" sz="1200" dirty="0" err="1">
                <a:latin typeface="Times New Roman"/>
                <a:cs typeface="Times New Roman"/>
              </a:rPr>
              <a:t>GF</a:t>
            </a:r>
            <a:r>
              <a:rPr lang="en-GB" sz="1200" i="1" dirty="0" err="1">
                <a:latin typeface="Times New Roman"/>
                <a:cs typeface="Times New Roman"/>
              </a:rPr>
              <a:t>Lr</a:t>
            </a:r>
            <a:r>
              <a:rPr lang="en-GB" sz="1200" dirty="0">
                <a:latin typeface="Times New Roman"/>
                <a:cs typeface="Times New Roman"/>
              </a:rPr>
              <a:t> mice (GraphPad Prism ®). </a:t>
            </a:r>
            <a:r>
              <a:rPr lang="en-GB" sz="1200" dirty="0" err="1">
                <a:latin typeface="Times New Roman"/>
                <a:cs typeface="Times New Roman"/>
              </a:rPr>
              <a:t>Geisser</a:t>
            </a:r>
            <a:r>
              <a:rPr lang="en-GB" sz="1200" dirty="0">
                <a:latin typeface="Times New Roman"/>
                <a:cs typeface="Times New Roman"/>
              </a:rPr>
              <a:t>-Greenhouse correction was not used. *p&lt;0.05, **p&lt;0.01 and ***p&lt;0.001 were considered statistically significant. </a:t>
            </a:r>
            <a:endParaRPr lang="en-US" sz="12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DCD7D44-11AC-204B-8D4E-989AE2552FF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81359" y="205920"/>
            <a:ext cx="2181025" cy="663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00876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5F866D9-BA6D-2047-A648-BA4342950F06}"/>
              </a:ext>
            </a:extLst>
          </p:cNvPr>
          <p:cNvGraphicFramePr>
            <a:graphicFrameLocks noGrp="1"/>
          </p:cNvGraphicFramePr>
          <p:nvPr/>
        </p:nvGraphicFramePr>
        <p:xfrm>
          <a:off x="1638795" y="1567537"/>
          <a:ext cx="8621485" cy="3622386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724297">
                  <a:extLst>
                    <a:ext uri="{9D8B030D-6E8A-4147-A177-3AD203B41FA5}">
                      <a16:colId xmlns:a16="http://schemas.microsoft.com/office/drawing/2014/main" val="367941068"/>
                    </a:ext>
                  </a:extLst>
                </a:gridCol>
                <a:gridCol w="1724297">
                  <a:extLst>
                    <a:ext uri="{9D8B030D-6E8A-4147-A177-3AD203B41FA5}">
                      <a16:colId xmlns:a16="http://schemas.microsoft.com/office/drawing/2014/main" val="584117430"/>
                    </a:ext>
                  </a:extLst>
                </a:gridCol>
                <a:gridCol w="1724297">
                  <a:extLst>
                    <a:ext uri="{9D8B030D-6E8A-4147-A177-3AD203B41FA5}">
                      <a16:colId xmlns:a16="http://schemas.microsoft.com/office/drawing/2014/main" val="4048632236"/>
                    </a:ext>
                  </a:extLst>
                </a:gridCol>
                <a:gridCol w="1724297">
                  <a:extLst>
                    <a:ext uri="{9D8B030D-6E8A-4147-A177-3AD203B41FA5}">
                      <a16:colId xmlns:a16="http://schemas.microsoft.com/office/drawing/2014/main" val="3334529675"/>
                    </a:ext>
                  </a:extLst>
                </a:gridCol>
                <a:gridCol w="1724297">
                  <a:extLst>
                    <a:ext uri="{9D8B030D-6E8A-4147-A177-3AD203B41FA5}">
                      <a16:colId xmlns:a16="http://schemas.microsoft.com/office/drawing/2014/main" val="2525192760"/>
                    </a:ext>
                  </a:extLst>
                </a:gridCol>
              </a:tblGrid>
              <a:tr h="415636">
                <a:tc>
                  <a:txBody>
                    <a:bodyPr/>
                    <a:lstStyle/>
                    <a:p>
                      <a:pPr marL="228600" algn="l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 algn="l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at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 algn="l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tyrat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 algn="l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ionat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 algn="l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cinat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0555957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 Duoden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(0.02)</a:t>
                      </a:r>
                      <a:r>
                        <a:rPr lang="en-GB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 baseline="30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010260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 Distal colon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73227035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 Caec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75675105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-Bt Duoden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0.05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0.03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0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95703433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-Bt Distal colon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 (0.2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 (0.17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(0.49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21271496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-Bt Caec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 (0.17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 (0.32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 (1.5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30827156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F Duoden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 (0.08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0.03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(0.04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4180063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F Distal colon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9 (0.59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 (0.29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 (0.08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(0.07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49170141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F Caec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1 (8.62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9 (2.63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 (1.67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0.0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2152700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-Lr Caecum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 (0.22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.0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 (0.35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/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(0.1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61410450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D4A30706-6436-D341-AD19-9E31281C5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1922" y="5266214"/>
            <a:ext cx="354937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 (standard deviation</a:t>
            </a:r>
            <a:r>
              <a:rPr lang="en-US" alt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 (mM) (n=5)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EEFED4A-E477-524B-ABBE-30AF3280F090}"/>
              </a:ext>
            </a:extLst>
          </p:cNvPr>
          <p:cNvSpPr txBox="1"/>
          <p:nvPr/>
        </p:nvSpPr>
        <p:spPr>
          <a:xfrm>
            <a:off x="1729484" y="941476"/>
            <a:ext cx="80847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.  Amounts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oide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rmentation products in the intestinal and caecal contents of SPF, GF and Bt- and Lr-conventionalised GF mice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3953F6C-78D7-DF4D-BAD7-0D09BC194D8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681359" y="113110"/>
            <a:ext cx="2181025" cy="663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270419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E22B786-8BEF-3940-A011-9D86F751108A}"/>
              </a:ext>
            </a:extLst>
          </p:cNvPr>
          <p:cNvSpPr txBox="1"/>
          <p:nvPr/>
        </p:nvSpPr>
        <p:spPr>
          <a:xfrm>
            <a:off x="1231839" y="1107393"/>
            <a:ext cx="97283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Supplementary Table 5. Mixed effects analysis to compare ChrA, GLP-1, GIP and 5-HT intestinal cell numbers in GF, APS and ±APS mice. </a:t>
            </a:r>
            <a:endParaRPr lang="en-GB" sz="1200" dirty="0">
              <a:latin typeface="Times New Roman"/>
              <a:cs typeface="Times New Roman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E0A03E4-68DC-4343-9C82-FBEF555BB9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7984402"/>
              </p:ext>
            </p:extLst>
          </p:nvPr>
        </p:nvGraphicFramePr>
        <p:xfrm>
          <a:off x="765810" y="1646050"/>
          <a:ext cx="10449882" cy="3804444"/>
        </p:xfrm>
        <a:graphic>
          <a:graphicData uri="http://schemas.openxmlformats.org/drawingml/2006/table">
            <a:tbl>
              <a:tblPr/>
              <a:tblGrid>
                <a:gridCol w="46102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34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027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90807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271746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uode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ejun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leum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xim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stal colon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1746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sk-SK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 valu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1746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A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90488" indent="0" algn="ctr" fontAlgn="ctr">
                        <a:lnSpc>
                          <a:spcPct val="110000"/>
                        </a:lnSpc>
                        <a:tabLst/>
                      </a:pP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2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7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9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65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79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2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4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37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98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CFA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49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&lt;</a:t>
                      </a: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50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31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1746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LP1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58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87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35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2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4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2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&lt;</a:t>
                      </a: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&lt;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CFA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8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6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3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2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1746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IP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0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1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54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0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03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&lt;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&lt;0.0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CFA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5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1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808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1746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HT</a:t>
                      </a:r>
                    </a:p>
                  </a:txBody>
                  <a:tcPr marL="11002" marR="11002" marT="11002" marB="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55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6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47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39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F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25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63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51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**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08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47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7174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CFA/±AP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887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26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826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119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802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s</a:t>
                      </a:r>
                    </a:p>
                  </a:txBody>
                  <a:tcPr marL="11002" marR="11002" marT="1100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BD72139E-FCA5-5847-B810-6CBE942CFB46}"/>
              </a:ext>
            </a:extLst>
          </p:cNvPr>
          <p:cNvSpPr/>
          <p:nvPr/>
        </p:nvSpPr>
        <p:spPr>
          <a:xfrm>
            <a:off x="1338993" y="6047687"/>
            <a:ext cx="987669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/>
                <a:cs typeface="Times New Roman"/>
              </a:rPr>
              <a:t>Two-Way ANOVA preformed on raw data comparing enteroendocrine cell numbers in GF, APS and ±APS mice (GraphPad Prism ®). </a:t>
            </a:r>
            <a:r>
              <a:rPr lang="en-GB" sz="1200" dirty="0" err="1">
                <a:latin typeface="Times New Roman"/>
                <a:cs typeface="Times New Roman"/>
              </a:rPr>
              <a:t>Geisser</a:t>
            </a:r>
            <a:r>
              <a:rPr lang="en-GB" sz="1200" dirty="0">
                <a:latin typeface="Times New Roman"/>
                <a:cs typeface="Times New Roman"/>
              </a:rPr>
              <a:t>-Greenhouse correction was not used. *p&lt;0.05, **p&lt;0.01 and ***p&lt;0.001 were considered statistically significant. </a:t>
            </a:r>
            <a:endParaRPr lang="en-US" sz="12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E9A93FB-2D40-F940-9B47-A24BFC696AE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82398" y="177168"/>
            <a:ext cx="2181025" cy="6639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274253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985</Words>
  <Application>Microsoft Macintosh PowerPoint</Application>
  <PresentationFormat>Widescreen</PresentationFormat>
  <Paragraphs>487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Carding (QIB)</dc:creator>
  <cp:lastModifiedBy>Simon Carding (QIB)</cp:lastModifiedBy>
  <cp:revision>8</cp:revision>
  <dcterms:created xsi:type="dcterms:W3CDTF">2020-09-25T19:37:35Z</dcterms:created>
  <dcterms:modified xsi:type="dcterms:W3CDTF">2020-09-30T19:36:36Z</dcterms:modified>
</cp:coreProperties>
</file>